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42" r:id="rId2"/>
  </p:sldIdLst>
  <p:sldSz cx="6858000" cy="9906000" type="A4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onz" initials="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99FF99"/>
    <a:srgbClr val="FFCCFF"/>
    <a:srgbClr val="0000FF"/>
    <a:srgbClr val="FF66FF"/>
    <a:srgbClr val="00FF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564" autoAdjust="0"/>
    <p:restoredTop sz="94660"/>
  </p:normalViewPr>
  <p:slideViewPr>
    <p:cSldViewPr snapToGrid="0">
      <p:cViewPr varScale="1">
        <p:scale>
          <a:sx n="68" d="100"/>
          <a:sy n="68" d="100"/>
        </p:scale>
        <p:origin x="528" y="5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1375" y="744538"/>
            <a:ext cx="2574925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153"/>
            <a:ext cx="5438140" cy="4466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D4352E6-89F8-4665-AABB-9BFB301042BF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8975009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218A52F-AD42-41C8-AC48-CB1B906BFC49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1304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3BD49A-75D7-4723-A655-57CFFCB46F1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505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C33628-4CC6-4D54-8BC2-3DBF802F5BE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3171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482557-481C-457D-BE70-B64C37DBA84A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0406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1A67C-E722-4B2E-B0D5-98A6C380816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668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28FB93-0856-4DC4-A2A3-DEF36F6FC7A8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766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BCB2924-FB0E-4717-9FFC-B45B7CE5D58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211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D52CF7-C59C-46A7-B7A9-B827D4CD9320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9121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F7A3AE-4DF2-4C09-A987-5AF06D3A195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7325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AF329C4-52D5-4A2F-879E-DAAFDB9BC19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387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EEFB6BD-4970-4287-A8F6-8A972207E21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5338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EE8B3270-0423-456C-9A24-B578D10E50EE}" type="slidenum">
              <a:rPr lang="en-US" altLang="ja-JP" smtClean="0">
                <a:solidFill>
                  <a:srgbClr val="000000"/>
                </a:solidFill>
                <a:ea typeface="ＭＳ Ｐゴシック" charset="-128"/>
              </a:rPr>
              <a:pPr/>
              <a:t>‹#›</a:t>
            </a:fld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7658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943350" y="69011"/>
            <a:ext cx="2805381" cy="4428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  <a:endParaRPr kumimoji="1" lang="ja-JP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46A784A-31F7-457C-9C0F-7F436518F9AA}"/>
              </a:ext>
            </a:extLst>
          </p:cNvPr>
          <p:cNvSpPr/>
          <p:nvPr/>
        </p:nvSpPr>
        <p:spPr>
          <a:xfrm>
            <a:off x="142875" y="898530"/>
            <a:ext cx="6007352" cy="2922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r>
              <a:rPr kumimoji="1"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Table 3. Statistical summary of Fig. 7.</a:t>
            </a:r>
            <a:endParaRPr kumimoji="1" lang="ja-JP" altLang="en-US" sz="1100" b="1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C30D3AC-CEC8-AD58-1213-4D49341EC6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0999410"/>
              </p:ext>
            </p:extLst>
          </p:nvPr>
        </p:nvGraphicFramePr>
        <p:xfrm>
          <a:off x="142875" y="1206155"/>
          <a:ext cx="6606268" cy="84539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25343">
                  <a:extLst>
                    <a:ext uri="{9D8B030D-6E8A-4147-A177-3AD203B41FA5}">
                      <a16:colId xmlns:a16="http://schemas.microsoft.com/office/drawing/2014/main" val="4075904724"/>
                    </a:ext>
                  </a:extLst>
                </a:gridCol>
                <a:gridCol w="2785931">
                  <a:extLst>
                    <a:ext uri="{9D8B030D-6E8A-4147-A177-3AD203B41FA5}">
                      <a16:colId xmlns:a16="http://schemas.microsoft.com/office/drawing/2014/main" val="1018800734"/>
                    </a:ext>
                  </a:extLst>
                </a:gridCol>
                <a:gridCol w="2694994">
                  <a:extLst>
                    <a:ext uri="{9D8B030D-6E8A-4147-A177-3AD203B41FA5}">
                      <a16:colId xmlns:a16="http://schemas.microsoft.com/office/drawing/2014/main" val="2185858558"/>
                    </a:ext>
                  </a:extLst>
                </a:gridCol>
              </a:tblGrid>
              <a:tr h="237168">
                <a:tc>
                  <a:txBody>
                    <a:bodyPr/>
                    <a:lstStyle/>
                    <a:p>
                      <a:pPr algn="ctr"/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</a:rPr>
                        <a:t>Measurement sit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</a:rPr>
                        <a:t>Statistics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9616830"/>
                  </a:ext>
                </a:extLst>
              </a:tr>
              <a:tr h="237168">
                <a:tc>
                  <a:txBody>
                    <a:bodyPr/>
                    <a:lstStyle/>
                    <a:p>
                      <a:pPr algn="just"/>
                      <a:r>
                        <a:rPr lang="en-US" sz="1000" b="1" u="sng" kern="1200" dirty="0">
                          <a:effectLst/>
                        </a:rPr>
                        <a:t>Left 4 cm</a:t>
                      </a:r>
                      <a:endParaRPr lang="ja-JP" sz="1000" b="1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</a:rPr>
                        <a:t>Significant effects of GROUP (F</a:t>
                      </a:r>
                      <a:r>
                        <a:rPr lang="en-US" sz="1000" kern="100" baseline="-25000" dirty="0">
                          <a:effectLst/>
                        </a:rPr>
                        <a:t>1, 22</a:t>
                      </a:r>
                      <a:r>
                        <a:rPr lang="en-US" sz="1000" kern="100" dirty="0">
                          <a:effectLst/>
                        </a:rPr>
                        <a:t> = 19.03, p = 0.0002), SEGMENT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3.188, p = 0.0008), and GROUP × SEGMENT interaction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3.738, p = 0.0001).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736491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9948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02897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&gt; 0.9999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2283779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8630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975158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9992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571693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9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Sidak’s multiple comparison test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783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5863580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***p = 0.000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66656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p = 0.000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4133885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2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**p = 0.002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380206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**p = 0.0044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371077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4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*p &lt; 0.000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697467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 dirty="0">
                          <a:effectLst/>
                        </a:rPr>
                        <a:t>L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494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8919356"/>
                  </a:ext>
                </a:extLst>
              </a:tr>
              <a:tr h="237168">
                <a:tc>
                  <a:txBody>
                    <a:bodyPr/>
                    <a:lstStyle/>
                    <a:p>
                      <a:pPr algn="just"/>
                      <a:r>
                        <a:rPr lang="en-US" sz="1000" b="1" u="sng" kern="1200" dirty="0">
                          <a:effectLst/>
                        </a:rPr>
                        <a:t>Left 2 cm</a:t>
                      </a:r>
                      <a:endParaRPr lang="ja-JP" sz="1000" b="1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</a:rPr>
                        <a:t>Significant effects of GROUP (F</a:t>
                      </a:r>
                      <a:r>
                        <a:rPr lang="en-US" sz="1000" kern="100" baseline="-25000" dirty="0">
                          <a:effectLst/>
                        </a:rPr>
                        <a:t>1, 22</a:t>
                      </a:r>
                      <a:r>
                        <a:rPr lang="en-US" sz="1000" kern="100" dirty="0">
                          <a:effectLst/>
                        </a:rPr>
                        <a:t> = 19.37, p = 0.0002), SEGMENT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2.769, p = 0.0031), but not GROUP × SEGMENT interaction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1.626, p = 0.1006).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583526427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7678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45607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977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5302898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704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1663198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3383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242583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9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5784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19394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8814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7805693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p = 0.0043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418241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2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052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772884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Sidak’s multiple comparison test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p = 0.003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823464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4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***p = 0.0002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277625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Sidak’s multiple comparison test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p = 0.0206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3147422"/>
                  </a:ext>
                </a:extLst>
              </a:tr>
              <a:tr h="237168">
                <a:tc>
                  <a:txBody>
                    <a:bodyPr/>
                    <a:lstStyle/>
                    <a:p>
                      <a:pPr algn="just"/>
                      <a:r>
                        <a:rPr lang="en-US" sz="1000" b="1" u="sng" kern="1200" dirty="0">
                          <a:effectLst/>
                        </a:rPr>
                        <a:t>Right 2 cm</a:t>
                      </a:r>
                      <a:endParaRPr lang="ja-JP" sz="1000" b="1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</a:rPr>
                        <a:t>Significant effects of GROUP (F</a:t>
                      </a:r>
                      <a:r>
                        <a:rPr lang="en-US" sz="1000" kern="100" baseline="-25000" dirty="0">
                          <a:effectLst/>
                        </a:rPr>
                        <a:t>1, 22</a:t>
                      </a:r>
                      <a:r>
                        <a:rPr lang="en-US" sz="1000" kern="100" dirty="0">
                          <a:effectLst/>
                        </a:rPr>
                        <a:t> = 25.74, p &lt; 0.0001) and GROUP × SEGMENT interaction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2.621, p = 0.0050), but not SEGMENT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1.791, p = 0.0635).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5032865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2078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3491107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Sidak’s multiple comparison test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9268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190593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p = 0.999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5786083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9924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325371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9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1183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7307727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2306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974907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p = 0.0008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372107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2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*p &lt; 0.000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0373561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>
                          <a:effectLst/>
                        </a:rPr>
                        <a:t>***p = 0.0007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524318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4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p = 0.0009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832622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p = 0.030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4948253"/>
                  </a:ext>
                </a:extLst>
              </a:tr>
              <a:tr h="237168">
                <a:tc>
                  <a:txBody>
                    <a:bodyPr/>
                    <a:lstStyle/>
                    <a:p>
                      <a:pPr algn="just"/>
                      <a:r>
                        <a:rPr lang="en-US" sz="1000" b="1" u="sng" kern="1200" dirty="0">
                          <a:effectLst/>
                        </a:rPr>
                        <a:t>Right 4 cm</a:t>
                      </a:r>
                      <a:endParaRPr lang="ja-JP" sz="1000" b="1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</a:rPr>
                        <a:t>Significant effects of GROUP (F</a:t>
                      </a:r>
                      <a:r>
                        <a:rPr lang="en-US" sz="1000" kern="100" baseline="-25000" dirty="0">
                          <a:effectLst/>
                        </a:rPr>
                        <a:t>1, 22</a:t>
                      </a:r>
                      <a:r>
                        <a:rPr lang="en-US" sz="1000" kern="100" dirty="0">
                          <a:effectLst/>
                        </a:rPr>
                        <a:t> = 35.11, p &lt; 0.0001), SEGMENT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3.103, p = 0.0010), and GROUP × SEGMENT interaction (F</a:t>
                      </a:r>
                      <a:r>
                        <a:rPr lang="en-US" sz="1000" kern="100" baseline="-25000" dirty="0">
                          <a:effectLst/>
                        </a:rPr>
                        <a:t>10, 220</a:t>
                      </a:r>
                      <a:r>
                        <a:rPr lang="en-US" sz="1000" kern="100" dirty="0">
                          <a:effectLst/>
                        </a:rPr>
                        <a:t> = 2.795, p = 0.0028).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44884397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9988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875169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0785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479551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715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5713129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 dirty="0">
                          <a:effectLst/>
                        </a:rPr>
                        <a:t>Th7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9209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166011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9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p = 0.2253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185553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Th1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p = 0.0139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2109334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1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p = 0.0019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883016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 dirty="0">
                          <a:effectLst/>
                        </a:rPr>
                        <a:t>L2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p = 0.0003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9463933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3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*p &lt; 0.000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8237945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4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p = 0.000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899963"/>
                  </a:ext>
                </a:extLst>
              </a:tr>
              <a:tr h="121625">
                <a:tc>
                  <a:txBody>
                    <a:bodyPr/>
                    <a:lstStyle/>
                    <a:p>
                      <a:pPr algn="just"/>
                      <a:r>
                        <a:rPr lang="en-US" sz="1000" u="sng" kern="1200">
                          <a:effectLst/>
                        </a:rPr>
                        <a:t>L5</a:t>
                      </a:r>
                      <a:endParaRPr lang="ja-JP" sz="1000" kern="1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Sidak’s multiple comparison test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kern="1200" dirty="0">
                          <a:effectLst/>
                        </a:rPr>
                        <a:t>****p &lt; 0.0001</a:t>
                      </a:r>
                      <a:endParaRPr lang="ja-JP" sz="1000" kern="1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4190" marR="14190" marT="3041" marB="3041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75651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7887135"/>
      </p:ext>
    </p:extLst>
  </p:cSld>
  <p:clrMapOvr>
    <a:masterClrMapping/>
  </p:clrMapOvr>
</p:sld>
</file>

<file path=ppt/theme/theme1.xml><?xml version="1.0" encoding="utf-8"?>
<a:theme xmlns:a="http://schemas.openxmlformats.org/drawingml/2006/main" name="1_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13</TotalTime>
  <Words>577</Words>
  <Application>Microsoft Office PowerPoint</Application>
  <PresentationFormat>A4 210 x 297 mm</PresentationFormat>
  <Paragraphs>1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1_標準デザイン</vt:lpstr>
      <vt:lpstr>PowerPoint プレゼンテーション</vt:lpstr>
    </vt:vector>
  </TitlesOfParts>
  <Company>Nagoy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ru TAGUCHI</dc:creator>
  <cp:lastModifiedBy>田口　徹</cp:lastModifiedBy>
  <cp:revision>1454</cp:revision>
  <cp:lastPrinted>2022-06-19T02:54:35Z</cp:lastPrinted>
  <dcterms:created xsi:type="dcterms:W3CDTF">2011-09-29T08:13:12Z</dcterms:created>
  <dcterms:modified xsi:type="dcterms:W3CDTF">2022-07-12T07:17:02Z</dcterms:modified>
</cp:coreProperties>
</file>